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84" r:id="rId2"/>
  </p:sldMasterIdLst>
  <p:sldIdLst>
    <p:sldId id="260" r:id="rId3"/>
  </p:sldIdLst>
  <p:sldSz cx="6858000" cy="9906000" type="A4"/>
  <p:notesSz cx="6858000" cy="9144000"/>
  <p:defaultTextStyle>
    <a:defPPr>
      <a:defRPr lang="en-US"/>
    </a:defPPr>
    <a:lvl1pPr marL="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1pPr>
    <a:lvl2pPr marL="457117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2pPr>
    <a:lvl3pPr marL="91423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3pPr>
    <a:lvl4pPr marL="137135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4pPr>
    <a:lvl5pPr marL="182847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5pPr>
    <a:lvl6pPr marL="2285588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6pPr>
    <a:lvl7pPr marL="2742705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7pPr>
    <a:lvl8pPr marL="3199823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8pPr>
    <a:lvl9pPr marL="3656940" algn="l" defTabSz="457117" rtl="0" eaLnBrk="1" latinLnBrk="0" hangingPunct="1">
      <a:defRPr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80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2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5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4" indent="0" algn="ctr">
              <a:buNone/>
              <a:defRPr sz="1500"/>
            </a:lvl2pPr>
            <a:lvl3pPr marL="685787" indent="0" algn="ctr">
              <a:buNone/>
              <a:defRPr sz="1350"/>
            </a:lvl3pPr>
            <a:lvl4pPr marL="1028681" indent="0" algn="ctr">
              <a:buNone/>
              <a:defRPr sz="1200"/>
            </a:lvl4pPr>
            <a:lvl5pPr marL="1371575" indent="0" algn="ctr">
              <a:buNone/>
              <a:defRPr sz="1200"/>
            </a:lvl5pPr>
            <a:lvl6pPr marL="1714468" indent="0" algn="ctr">
              <a:buNone/>
              <a:defRPr sz="1200"/>
            </a:lvl6pPr>
            <a:lvl7pPr marL="2057362" indent="0" algn="ctr">
              <a:buNone/>
              <a:defRPr sz="1200"/>
            </a:lvl7pPr>
            <a:lvl8pPr marL="2400256" indent="0" algn="ctr">
              <a:buNone/>
              <a:defRPr sz="1200"/>
            </a:lvl8pPr>
            <a:lvl9pPr marL="274315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9093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083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32025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09772-E514-45B9-8CF4-92DF4A6135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0838"/>
            <a:ext cx="5143500" cy="34496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0B107E-D851-4A12-AF94-3795778259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238"/>
            <a:ext cx="5143500" cy="23923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ED4F1-9F3A-456F-80DC-5DED50F7BF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43F402-3486-4322-8248-4BAC830984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552FD9-FD18-4157-9687-A8A4A14A4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741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01DA3B-973B-4351-A78A-50D6F2F52E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C3936-2E45-47F5-88F3-CC0FBE8D54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13BC8E-2B2C-4037-83EA-D6DE8A5C7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4022F1-9174-4AA9-9B99-05226159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E1F1A-C3FB-42B5-96B2-AA7DDB520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36190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9AF10E-E890-48B5-B9DA-7DB62C863D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313" y="2470150"/>
            <a:ext cx="5915025" cy="4119563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8AC4CF-EB1B-4163-AB69-524FAC55FA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313" y="6629400"/>
            <a:ext cx="5915025" cy="216693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06CEA9-E99A-48A1-9606-17174C455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866BD5-BB1E-4126-A0A8-E3E1A846B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A13870-8824-49E0-9A21-3BF5A1F6B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96786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4B2F9F-6256-443A-9A23-B42146D66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92E53B4-9221-49A7-A6E7-FCCEF6836A5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6838"/>
            <a:ext cx="2881312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59B7275-D924-43C6-A4C7-66B557518B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505200" y="2636838"/>
            <a:ext cx="2881313" cy="62849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BD0C1F-73DC-43E9-B48D-D786852B7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895FBBF-74A2-4E6B-BC75-1E37657A2B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C51576-CC48-498E-8765-DE56DAE5A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26433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703F30-C803-47E4-8347-5E6023980D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527050"/>
            <a:ext cx="5915025" cy="19145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BA377A-880F-4EC6-97FF-CAEBE1C583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3075" y="2428875"/>
            <a:ext cx="2900363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86F3534-8A8F-4D28-B44D-79D31C57D8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3075" y="3617913"/>
            <a:ext cx="2900363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AE94583-C1AF-41D9-9033-6050FDE773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875"/>
            <a:ext cx="2916237" cy="11890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ADEE9E9-1F08-4E9A-A20D-A5DF3777F69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7913"/>
            <a:ext cx="2916237" cy="532288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FC1012B-0494-4A31-8816-3C5926416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B1BBDD3-2A6F-4A19-8A39-887DDC0851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8116A3-8B03-4714-8830-66560B948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4749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628F8-CF4E-488A-93AF-1BC5118B80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4E3929-5A95-436D-B902-CE72CF6B29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BAB1B8-0FA4-41DE-BD94-D5A883C13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025A80C-9A52-4647-A2A9-6F6FB9C3A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2281554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E630A6-7184-47A2-9972-68A98471D2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C77312-F2DE-4132-9397-D14795928D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4B088FC-332A-4E9A-9CD0-BB20FAD2E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81809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48BCF8-8542-4164-8762-60C12241F7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438C008-472E-4C2E-A842-76D1B9F721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83FB18-C304-4CC4-9A13-ED8C38F16B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B6FC1-91E3-4769-A0B1-C0DCC4B705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6C68DB-9C40-4AE0-96F4-82A16DC4E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5ABE2B-7320-4B70-8DF1-4A75C7DFA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344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0801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4E560F-FBA5-4A57-BAAB-B5B245AF65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3075" y="660400"/>
            <a:ext cx="2211388" cy="23114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06DF3D-976B-41C0-8413-E44AB34432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6238" y="1425575"/>
            <a:ext cx="3471862" cy="704056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F99E36D-E537-456F-A46E-D956F8FA29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3075" y="2971800"/>
            <a:ext cx="2211388" cy="550545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1EBEAB-7AD1-4AC6-8783-9A3BFDD6F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D40531-89C0-454E-A9D7-6412C7CC6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B01019-E7CE-47CA-92FF-7434AF3B2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857353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23F2D-2D6D-4BF4-96F3-A38D85AA68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284063-D278-4428-A223-48C303113D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9DE4D9-9DFD-4B19-9A4B-F4A9711AF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F7B78-D83E-482B-8423-D48D005E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5AAD84-DF58-4E58-B84B-940D4E8584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0854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FD37CB-620B-4C5A-886D-763C2B493C6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8550" y="527050"/>
            <a:ext cx="1477963" cy="8394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BB42B9-5DBB-4588-803A-5E31F1002E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8" y="527050"/>
            <a:ext cx="4284662" cy="8394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98DE5B-9C7F-4C6C-88C6-A7DE08E4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AABC10-CB61-4AD4-A91B-39588FE54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55FAA9-D874-44EA-9C94-8FF9115EC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3239018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9165A-EB3D-4DE9-956A-6302BF2737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9ED5DFB-FAC6-419C-B452-9ED84B38F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69401A-86BB-478E-8EE9-747E0FDF4D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50C80AC-60F4-4902-9B12-604D07091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129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7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7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8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7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6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5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635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877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4" indent="0">
              <a:buNone/>
              <a:defRPr sz="1500" b="1"/>
            </a:lvl2pPr>
            <a:lvl3pPr marL="685787" indent="0">
              <a:buNone/>
              <a:defRPr sz="1350" b="1"/>
            </a:lvl3pPr>
            <a:lvl4pPr marL="1028681" indent="0">
              <a:buNone/>
              <a:defRPr sz="1200" b="1"/>
            </a:lvl4pPr>
            <a:lvl5pPr marL="1371575" indent="0">
              <a:buNone/>
              <a:defRPr sz="1200" b="1"/>
            </a:lvl5pPr>
            <a:lvl6pPr marL="1714468" indent="0">
              <a:buNone/>
              <a:defRPr sz="1200" b="1"/>
            </a:lvl6pPr>
            <a:lvl7pPr marL="2057362" indent="0">
              <a:buNone/>
              <a:defRPr sz="1200" b="1"/>
            </a:lvl7pPr>
            <a:lvl8pPr marL="2400256" indent="0">
              <a:buNone/>
              <a:defRPr sz="1200" b="1"/>
            </a:lvl8pPr>
            <a:lvl9pPr marL="27431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81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886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091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3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4" indent="0">
              <a:buNone/>
              <a:defRPr sz="2100"/>
            </a:lvl2pPr>
            <a:lvl3pPr marL="685787" indent="0">
              <a:buNone/>
              <a:defRPr sz="1800"/>
            </a:lvl3pPr>
            <a:lvl4pPr marL="1028681" indent="0">
              <a:buNone/>
              <a:defRPr sz="1500"/>
            </a:lvl4pPr>
            <a:lvl5pPr marL="1371575" indent="0">
              <a:buNone/>
              <a:defRPr sz="1500"/>
            </a:lvl5pPr>
            <a:lvl6pPr marL="1714468" indent="0">
              <a:buNone/>
              <a:defRPr sz="1500"/>
            </a:lvl6pPr>
            <a:lvl7pPr marL="2057362" indent="0">
              <a:buNone/>
              <a:defRPr sz="1500"/>
            </a:lvl7pPr>
            <a:lvl8pPr marL="2400256" indent="0">
              <a:buNone/>
              <a:defRPr sz="1500"/>
            </a:lvl8pPr>
            <a:lvl9pPr marL="274315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1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94" indent="0">
              <a:buNone/>
              <a:defRPr sz="1050"/>
            </a:lvl2pPr>
            <a:lvl3pPr marL="685787" indent="0">
              <a:buNone/>
              <a:defRPr sz="900"/>
            </a:lvl3pPr>
            <a:lvl4pPr marL="1028681" indent="0">
              <a:buNone/>
              <a:defRPr sz="750"/>
            </a:lvl4pPr>
            <a:lvl5pPr marL="1371575" indent="0">
              <a:buNone/>
              <a:defRPr sz="750"/>
            </a:lvl5pPr>
            <a:lvl6pPr marL="1714468" indent="0">
              <a:buNone/>
              <a:defRPr sz="750"/>
            </a:lvl6pPr>
            <a:lvl7pPr marL="2057362" indent="0">
              <a:buNone/>
              <a:defRPr sz="750"/>
            </a:lvl7pPr>
            <a:lvl8pPr marL="2400256" indent="0">
              <a:buNone/>
              <a:defRPr sz="750"/>
            </a:lvl8pPr>
            <a:lvl9pPr marL="274315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63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slideLayout" Target="../slideLayouts/slideLayout23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8FB57F-F3C2-44F1-BDA1-59B168DF83F1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89744-C74C-450D-B213-431512EDC5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4450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7" indent="-171447" algn="l" defTabSz="68578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41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34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8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22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15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09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03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97" indent="-171447" algn="l" defTabSz="68578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4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7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81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75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68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62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56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50" algn="l" defTabSz="685787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FEA7FF-5392-453F-B97E-628C7A0696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050"/>
            <a:ext cx="5915025" cy="19145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00A679-CADD-47AC-953E-FE520426F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6838"/>
            <a:ext cx="5915025" cy="62849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79E62A-4952-4FF1-8805-218D387117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923A10-7854-46EF-8C3E-A0D0F7144EA0}" type="datetimeFigureOut">
              <a:rPr lang="en-US" smtClean="0"/>
              <a:t>8/1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94C13-E29D-41AC-93DC-B46213509B0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FB7D7B-27F5-48A9-AB98-28A54E3D8A4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FE436-AB39-4C72-B27E-0DEF0B5762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097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1687F51D-B7FC-4C4C-8ACC-5CEA8C41A32C}"/>
              </a:ext>
            </a:extLst>
          </p:cNvPr>
          <p:cNvSpPr txBox="1"/>
          <p:nvPr/>
        </p:nvSpPr>
        <p:spPr>
          <a:xfrm>
            <a:off x="0" y="-29165"/>
            <a:ext cx="47823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2B21550-B698-6A33-C64B-BA7BB3EBE092}"/>
              </a:ext>
            </a:extLst>
          </p:cNvPr>
          <p:cNvGrpSpPr/>
          <p:nvPr/>
        </p:nvGrpSpPr>
        <p:grpSpPr>
          <a:xfrm>
            <a:off x="150821" y="802647"/>
            <a:ext cx="3662860" cy="3212322"/>
            <a:chOff x="13661" y="802647"/>
            <a:chExt cx="3662860" cy="3212322"/>
          </a:xfrm>
        </p:grpSpPr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99A0890-D775-F260-57A6-3AAD0B7D72C3}"/>
                </a:ext>
              </a:extLst>
            </p:cNvPr>
            <p:cNvSpPr txBox="1"/>
            <p:nvPr/>
          </p:nvSpPr>
          <p:spPr>
            <a:xfrm>
              <a:off x="342145" y="3536620"/>
              <a:ext cx="2244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C883129-96C5-4DFE-5F34-9168310A71FF}"/>
                </a:ext>
              </a:extLst>
            </p:cNvPr>
            <p:cNvSpPr txBox="1"/>
            <p:nvPr/>
          </p:nvSpPr>
          <p:spPr>
            <a:xfrm>
              <a:off x="741745" y="3536818"/>
              <a:ext cx="4221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767127C-BC0D-5074-6D6C-F51159EB515B}"/>
                </a:ext>
              </a:extLst>
            </p:cNvPr>
            <p:cNvSpPr txBox="1"/>
            <p:nvPr/>
          </p:nvSpPr>
          <p:spPr>
            <a:xfrm>
              <a:off x="1233369" y="3536838"/>
              <a:ext cx="4221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0858495-714F-CCD7-0066-6BFCFA6BA624}"/>
                </a:ext>
              </a:extLst>
            </p:cNvPr>
            <p:cNvSpPr txBox="1"/>
            <p:nvPr/>
          </p:nvSpPr>
          <p:spPr>
            <a:xfrm>
              <a:off x="1733038" y="3536738"/>
              <a:ext cx="4221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27CDC9F-5FAF-38D8-D2E7-7C56760AD2F9}"/>
                </a:ext>
              </a:extLst>
            </p:cNvPr>
            <p:cNvSpPr txBox="1"/>
            <p:nvPr/>
          </p:nvSpPr>
          <p:spPr>
            <a:xfrm>
              <a:off x="2229636" y="3538029"/>
              <a:ext cx="422141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AE548AE-5124-B58D-8A2B-64153309492D}"/>
                </a:ext>
              </a:extLst>
            </p:cNvPr>
            <p:cNvSpPr txBox="1"/>
            <p:nvPr/>
          </p:nvSpPr>
          <p:spPr>
            <a:xfrm>
              <a:off x="2691436" y="3538029"/>
              <a:ext cx="4982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4766819-B77D-F4CE-8B35-ED11AD558917}"/>
                </a:ext>
              </a:extLst>
            </p:cNvPr>
            <p:cNvSpPr txBox="1"/>
            <p:nvPr/>
          </p:nvSpPr>
          <p:spPr>
            <a:xfrm>
              <a:off x="3178297" y="3539889"/>
              <a:ext cx="4982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graphicFrame>
          <p:nvGraphicFramePr>
            <p:cNvPr id="70" name="Object 69">
              <a:extLst>
                <a:ext uri="{FF2B5EF4-FFF2-40B4-BE49-F238E27FC236}">
                  <a16:creationId xmlns:a16="http://schemas.microsoft.com/office/drawing/2014/main" id="{5356CB3A-E2B9-226C-B8F2-7B6E8CF8CDA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98865450"/>
                </p:ext>
              </p:extLst>
            </p:nvPr>
          </p:nvGraphicFramePr>
          <p:xfrm>
            <a:off x="392150" y="890627"/>
            <a:ext cx="3096215" cy="27593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6" name="Prism Project" r:id="rId3" imgW="6624000" imgH="5904000" progId="Prism5.Document">
                    <p:embed/>
                  </p:oleObj>
                </mc:Choice>
                <mc:Fallback>
                  <p:oleObj name="Prism Project" r:id="rId3" imgW="6624000" imgH="5904000" progId="Prism5.Document">
                    <p:embed/>
                    <p:pic>
                      <p:nvPicPr>
                        <p:cNvPr id="116" name="Object 115">
                          <a:extLst>
                            <a:ext uri="{FF2B5EF4-FFF2-40B4-BE49-F238E27FC236}">
                              <a16:creationId xmlns:a16="http://schemas.microsoft.com/office/drawing/2014/main" id="{F254DB01-3E3D-BEA4-9E84-2D89A5353ED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92150" y="890627"/>
                          <a:ext cx="3096215" cy="27593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F5838B4-A8E8-C0BA-0F92-623C4663B4C4}"/>
                </a:ext>
              </a:extLst>
            </p:cNvPr>
            <p:cNvSpPr txBox="1"/>
            <p:nvPr/>
          </p:nvSpPr>
          <p:spPr>
            <a:xfrm>
              <a:off x="1439060" y="3737970"/>
              <a:ext cx="10199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Time (</a:t>
              </a:r>
              <a:r>
                <a:rPr lang="en-US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mins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6DA92ABC-CB6B-F7A3-C2D9-8C3116F07CE9}"/>
                </a:ext>
              </a:extLst>
            </p:cNvPr>
            <p:cNvSpPr txBox="1"/>
            <p:nvPr/>
          </p:nvSpPr>
          <p:spPr>
            <a:xfrm>
              <a:off x="1655510" y="802647"/>
              <a:ext cx="13882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10 mM CaCl</a:t>
              </a:r>
              <a:r>
                <a:rPr lang="en-US" sz="12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7F08AFF-07DE-05F1-87C6-5A8335FC72A4}"/>
                </a:ext>
              </a:extLst>
            </p:cNvPr>
            <p:cNvSpPr txBox="1"/>
            <p:nvPr/>
          </p:nvSpPr>
          <p:spPr>
            <a:xfrm>
              <a:off x="290661" y="3429062"/>
              <a:ext cx="1387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796801B-CE08-3CC3-8284-4EE68130C116}"/>
                </a:ext>
              </a:extLst>
            </p:cNvPr>
            <p:cNvSpPr txBox="1"/>
            <p:nvPr/>
          </p:nvSpPr>
          <p:spPr>
            <a:xfrm>
              <a:off x="150515" y="2926204"/>
              <a:ext cx="3514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72926CC9-B21F-E18E-FC41-A8C832A8D4D2}"/>
                </a:ext>
              </a:extLst>
            </p:cNvPr>
            <p:cNvSpPr txBox="1"/>
            <p:nvPr/>
          </p:nvSpPr>
          <p:spPr>
            <a:xfrm>
              <a:off x="153322" y="1899566"/>
              <a:ext cx="3514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3601A495-B506-CE22-D4F4-FB895C27E6B9}"/>
                </a:ext>
              </a:extLst>
            </p:cNvPr>
            <p:cNvSpPr txBox="1"/>
            <p:nvPr/>
          </p:nvSpPr>
          <p:spPr>
            <a:xfrm>
              <a:off x="150515" y="2408368"/>
              <a:ext cx="3514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3C6825B4-8150-6F92-79F0-B981A00C9B8A}"/>
                </a:ext>
              </a:extLst>
            </p:cNvPr>
            <p:cNvSpPr txBox="1"/>
            <p:nvPr/>
          </p:nvSpPr>
          <p:spPr>
            <a:xfrm>
              <a:off x="152421" y="1396646"/>
              <a:ext cx="3514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A5A3FE99-AC1F-EB3C-43D7-CA4F8BF3B31E}"/>
                </a:ext>
              </a:extLst>
            </p:cNvPr>
            <p:cNvSpPr txBox="1"/>
            <p:nvPr/>
          </p:nvSpPr>
          <p:spPr>
            <a:xfrm>
              <a:off x="149096" y="878613"/>
              <a:ext cx="3514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AE8D551-AB5F-2834-3140-2AFFEA626758}"/>
                </a:ext>
              </a:extLst>
            </p:cNvPr>
            <p:cNvSpPr txBox="1"/>
            <p:nvPr/>
          </p:nvSpPr>
          <p:spPr>
            <a:xfrm rot="16200000">
              <a:off x="-517366" y="2131809"/>
              <a:ext cx="13390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200" dirty="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/F0 (%)</a:t>
              </a:r>
            </a:p>
          </p:txBody>
        </p:sp>
      </p:grpSp>
      <p:graphicFrame>
        <p:nvGraphicFramePr>
          <p:cNvPr id="83" name="Object 82">
            <a:extLst>
              <a:ext uri="{FF2B5EF4-FFF2-40B4-BE49-F238E27FC236}">
                <a16:creationId xmlns:a16="http://schemas.microsoft.com/office/drawing/2014/main" id="{BB4043BB-38A6-8014-1DBC-CFCB2594FA4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27753653"/>
              </p:ext>
            </p:extLst>
          </p:nvPr>
        </p:nvGraphicFramePr>
        <p:xfrm>
          <a:off x="4618038" y="723900"/>
          <a:ext cx="1127125" cy="2974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5" r:id="rId5" imgW="2952000" imgH="4068000" progId="Prism5.Document">
                  <p:embed/>
                </p:oleObj>
              </mc:Choice>
              <mc:Fallback>
                <p:oleObj name="Prism 5" r:id="rId5" imgW="2952000" imgH="4068000" progId="Prism5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03302DA0-D3FD-58C0-3D89-21922BA4416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18038" y="723900"/>
                        <a:ext cx="1127125" cy="2974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4" name="TextBox 83">
            <a:extLst>
              <a:ext uri="{FF2B5EF4-FFF2-40B4-BE49-F238E27FC236}">
                <a16:creationId xmlns:a16="http://schemas.microsoft.com/office/drawing/2014/main" id="{562ABC21-FCBB-A1C0-D66A-CD29833DE47A}"/>
              </a:ext>
            </a:extLst>
          </p:cNvPr>
          <p:cNvSpPr txBox="1"/>
          <p:nvPr/>
        </p:nvSpPr>
        <p:spPr>
          <a:xfrm>
            <a:off x="4541169" y="3576685"/>
            <a:ext cx="7739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PF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28FCF254-EC3C-4D83-2659-CB767B2C3EDC}"/>
              </a:ext>
            </a:extLst>
          </p:cNvPr>
          <p:cNvSpPr txBox="1"/>
          <p:nvPr/>
        </p:nvSpPr>
        <p:spPr>
          <a:xfrm>
            <a:off x="4959188" y="3572609"/>
            <a:ext cx="101990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Cl</a:t>
            </a:r>
            <a:r>
              <a:rPr lang="en-US" sz="11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E2ADBED-ED19-37C1-C867-48F76F29EF1E}"/>
              </a:ext>
            </a:extLst>
          </p:cNvPr>
          <p:cNvSpPr txBox="1"/>
          <p:nvPr/>
        </p:nvSpPr>
        <p:spPr>
          <a:xfrm>
            <a:off x="4515700" y="3450447"/>
            <a:ext cx="1387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522CB61-C4DC-7495-246C-A4CCDB705095}"/>
              </a:ext>
            </a:extLst>
          </p:cNvPr>
          <p:cNvSpPr txBox="1"/>
          <p:nvPr/>
        </p:nvSpPr>
        <p:spPr>
          <a:xfrm>
            <a:off x="4375554" y="2914931"/>
            <a:ext cx="3514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E8A5EA4-520C-A409-38D9-DF7EE0345D65}"/>
              </a:ext>
            </a:extLst>
          </p:cNvPr>
          <p:cNvSpPr txBox="1"/>
          <p:nvPr/>
        </p:nvSpPr>
        <p:spPr>
          <a:xfrm>
            <a:off x="4378361" y="1850192"/>
            <a:ext cx="3514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0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FA66AD74-E497-EE9B-E3EB-EECA654CC603}"/>
              </a:ext>
            </a:extLst>
          </p:cNvPr>
          <p:cNvSpPr txBox="1"/>
          <p:nvPr/>
        </p:nvSpPr>
        <p:spPr>
          <a:xfrm>
            <a:off x="4375554" y="2380766"/>
            <a:ext cx="3514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CCADEF8-E8DF-6106-1FC1-140280FBAB68}"/>
              </a:ext>
            </a:extLst>
          </p:cNvPr>
          <p:cNvSpPr txBox="1"/>
          <p:nvPr/>
        </p:nvSpPr>
        <p:spPr>
          <a:xfrm>
            <a:off x="4377460" y="1314614"/>
            <a:ext cx="3514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A52A732-3ABE-5180-7FEF-8B558758884B}"/>
              </a:ext>
            </a:extLst>
          </p:cNvPr>
          <p:cNvSpPr txBox="1"/>
          <p:nvPr/>
        </p:nvSpPr>
        <p:spPr>
          <a:xfrm>
            <a:off x="4374135" y="780252"/>
            <a:ext cx="3514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F6E455EE-56AB-775B-0ECB-C334037CC167}"/>
              </a:ext>
            </a:extLst>
          </p:cNvPr>
          <p:cNvSpPr txBox="1"/>
          <p:nvPr/>
        </p:nvSpPr>
        <p:spPr>
          <a:xfrm rot="16200000">
            <a:off x="3628995" y="2072729"/>
            <a:ext cx="1339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/F0 (%)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2E429FC5-7B99-A6C2-E019-93BCDAF7ADD5}"/>
              </a:ext>
            </a:extLst>
          </p:cNvPr>
          <p:cNvSpPr txBox="1"/>
          <p:nvPr/>
        </p:nvSpPr>
        <p:spPr>
          <a:xfrm>
            <a:off x="5160481" y="1045309"/>
            <a:ext cx="57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D190D3DA-423D-E2D5-B297-C20959114EFB}"/>
              </a:ext>
            </a:extLst>
          </p:cNvPr>
          <p:cNvSpPr txBox="1"/>
          <p:nvPr/>
        </p:nvSpPr>
        <p:spPr>
          <a:xfrm>
            <a:off x="180220" y="4093635"/>
            <a:ext cx="66234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 mM CaCl</a:t>
            </a:r>
            <a:r>
              <a:rPr lang="en-US" sz="11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F wash does not stimulate detectable Ca</a:t>
            </a:r>
            <a:r>
              <a:rPr lang="en-US" sz="11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+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ignals. A) Representative trace showing 1 mM CaCl</a:t>
            </a:r>
            <a:r>
              <a:rPr lang="en-US" sz="11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F application followed by 10 mM CaCl</a:t>
            </a:r>
            <a:r>
              <a:rPr lang="en-US" sz="11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plication (grey box). B) Maximal amplitudes of 1 mM CaCl</a:t>
            </a:r>
            <a:r>
              <a:rPr lang="en-US" sz="110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F signals (black bar)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10 mM CaCl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rey bar). *** Significantly different from 1 mM CaCl</a:t>
            </a:r>
            <a:r>
              <a:rPr lang="en-US" sz="1100" baseline="-25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PF (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&lt; 0.0001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25.26 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f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= 249; paired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– test). N = 5 intestines from 5 individual female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caris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l values are represented as means ± SEM. </a:t>
            </a:r>
            <a:endParaRPr lang="en-US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6B3DBCF-A951-653C-DE1C-4D658796A537}"/>
              </a:ext>
            </a:extLst>
          </p:cNvPr>
          <p:cNvSpPr txBox="1"/>
          <p:nvPr/>
        </p:nvSpPr>
        <p:spPr>
          <a:xfrm>
            <a:off x="4095" y="610739"/>
            <a:ext cx="329645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1DC122C0-F9CD-58AB-3FDF-548C8FBDCBAF}"/>
              </a:ext>
            </a:extLst>
          </p:cNvPr>
          <p:cNvSpPr txBox="1"/>
          <p:nvPr/>
        </p:nvSpPr>
        <p:spPr>
          <a:xfrm>
            <a:off x="3835007" y="616421"/>
            <a:ext cx="329645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39540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90</TotalTime>
  <Words>142</Words>
  <Application>Microsoft Office PowerPoint</Application>
  <PresentationFormat>A4 Paper (210x297 mm)</PresentationFormat>
  <Paragraphs>3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Custom Design</vt:lpstr>
      <vt:lpstr>GraphPad Prism 5 Project</vt:lpstr>
      <vt:lpstr>Prism 5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Williams</dc:creator>
  <cp:lastModifiedBy>martinlab</cp:lastModifiedBy>
  <cp:revision>137</cp:revision>
  <dcterms:created xsi:type="dcterms:W3CDTF">2020-10-13T16:20:28Z</dcterms:created>
  <dcterms:modified xsi:type="dcterms:W3CDTF">2022-08-12T17:56:35Z</dcterms:modified>
</cp:coreProperties>
</file>